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sanne Rinné" initials="SR" lastIdx="2" clrIdx="0">
    <p:extLst>
      <p:ext uri="{19B8F6BF-5375-455C-9EA6-DF929625EA0E}">
        <p15:presenceInfo xmlns:p15="http://schemas.microsoft.com/office/powerpoint/2012/main" userId="S-1-5-21-3130912094-819552442-996794312-1004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73E61"/>
    <a:srgbClr val="289D61"/>
    <a:srgbClr val="434EA3"/>
    <a:srgbClr val="808080"/>
    <a:srgbClr val="EC3023"/>
    <a:srgbClr val="5B2439"/>
    <a:srgbClr val="4D4D4D"/>
    <a:srgbClr val="BFBFB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unkle Formatvorlag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 autoAdjust="0"/>
    <p:restoredTop sz="94660"/>
  </p:normalViewPr>
  <p:slideViewPr>
    <p:cSldViewPr>
      <p:cViewPr varScale="1">
        <p:scale>
          <a:sx n="100" d="100"/>
          <a:sy n="100" d="100"/>
        </p:scale>
        <p:origin x="3072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-13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AFAC2-6B95-4CCA-A518-DAD86D87BB39}" type="datetimeFigureOut">
              <a:rPr lang="de-DE" smtClean="0"/>
              <a:pPr/>
              <a:t>2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8D0EE-8FED-43AF-AE9D-B664F866D78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2881593"/>
              </p:ext>
            </p:extLst>
          </p:nvPr>
        </p:nvGraphicFramePr>
        <p:xfrm>
          <a:off x="1981200" y="914400"/>
          <a:ext cx="2895600" cy="3337560"/>
        </p:xfrm>
        <a:graphic>
          <a:graphicData uri="http://schemas.openxmlformats.org/drawingml/2006/table">
            <a:tbl>
              <a:tblPr firstRow="1" firstCol="1" bandRow="1">
                <a:tableStyleId>{E8034E78-7F5D-4C2E-B375-FC64B27BC917}</a:tableStyleId>
              </a:tblPr>
              <a:tblGrid>
                <a:gridCol w="175895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3665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2556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ce field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erions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mperature (K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d dimensions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dielectric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brane dielectric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group</a:t>
                      </a: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ielectric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vent dielectric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brane thickness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brane bottom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group</a:t>
                      </a: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hickness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/lower exclusion radii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d center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ution method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undary condition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brane potential (mV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rge model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model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spline width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n initial position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n final position (Å) 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of ion steps</a:t>
                      </a:r>
                      <a:endParaRPr lang="de-DE" sz="9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BER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|e|, 0.1 M, 2.0 Å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8.15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 x 161 x 161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9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13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igin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be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ero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2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2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, 0, -30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, 0, 20)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de-DE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E36C40B3-F65B-4CD2-868C-DC10F45AD198}"/>
              </a:ext>
            </a:extLst>
          </p:cNvPr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File 1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5574936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Bildschirmpräsentation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-Design</vt:lpstr>
      <vt:lpstr>PowerPoint-Präsentation</vt:lpstr>
    </vt:vector>
  </TitlesOfParts>
  <Company>Philipps-Universität Marbur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inne</dc:creator>
  <cp:lastModifiedBy>Niels Decher</cp:lastModifiedBy>
  <cp:revision>258</cp:revision>
  <cp:lastPrinted>2018-10-11T15:17:22Z</cp:lastPrinted>
  <dcterms:created xsi:type="dcterms:W3CDTF">2015-03-16T13:54:08Z</dcterms:created>
  <dcterms:modified xsi:type="dcterms:W3CDTF">2018-11-29T10:50:46Z</dcterms:modified>
</cp:coreProperties>
</file>